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2366D6-BEA2-4C3E-9F3C-7C6CA9A5F77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36573D-A5C1-45AB-A7AA-F9E742BD526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4D7C19-C967-4DF9-9427-710E7D7E7E0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677641-CEDE-4EF7-B2A3-C72D234416D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452064-F13B-40FE-A230-7E5A1B6F7A5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7250BF-3CCD-4854-B0D3-4648BB5B169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C14EEC-4693-410A-BB7E-D218D39F3AA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84025A-45B8-46C8-9BAD-4363314F5A8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EA8D88-DB9E-4611-901A-5DB450F40DA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DABD81-E7B6-4980-84D1-284B06A3976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7F6559-3E0B-4E85-9995-9D6A79CA25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29CE85-11EA-49A0-AA30-9AD37884E4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EE08758-53C3-4DC3-9AA4-F5BF472A80AA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"/>
          <p:cNvSpPr/>
          <p:nvPr/>
        </p:nvSpPr>
        <p:spPr>
          <a:xfrm>
            <a:off x="125280" y="405000"/>
            <a:ext cx="6921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SimSun"/>
              </a:rPr>
              <a:t>Additional file 11A. GAM plots for MAQC2 gene level brain data set using procedure 1.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2" descr=""/>
          <p:cNvPicPr/>
          <p:nvPr/>
        </p:nvPicPr>
        <p:blipFill>
          <a:blip r:embed="rId1"/>
          <a:stretch/>
        </p:blipFill>
        <p:spPr>
          <a:xfrm>
            <a:off x="1413000" y="1593720"/>
            <a:ext cx="6318000" cy="3670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Rectangle 1"/>
          <p:cNvSpPr/>
          <p:nvPr/>
        </p:nvSpPr>
        <p:spPr>
          <a:xfrm>
            <a:off x="127080" y="829080"/>
            <a:ext cx="6845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SimSun"/>
              </a:rPr>
              <a:t>Additional file 11B. GAM plots for MAQC2 gene level UHR data set using procedure 1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Rectangle 8"/>
          <p:cNvSpPr/>
          <p:nvPr/>
        </p:nvSpPr>
        <p:spPr>
          <a:xfrm>
            <a:off x="2268360" y="1281240"/>
            <a:ext cx="35892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5" name="Picture 2" descr=""/>
          <p:cNvPicPr/>
          <p:nvPr/>
        </p:nvPicPr>
        <p:blipFill>
          <a:blip r:embed="rId1"/>
          <a:stretch/>
        </p:blipFill>
        <p:spPr>
          <a:xfrm>
            <a:off x="1387440" y="1593720"/>
            <a:ext cx="6369120" cy="3670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Rectangle 1"/>
          <p:cNvSpPr/>
          <p:nvPr/>
        </p:nvSpPr>
        <p:spPr>
          <a:xfrm>
            <a:off x="119520" y="817920"/>
            <a:ext cx="5997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SimSun"/>
              </a:rPr>
              <a:t>Additional file 11C. GAM plots for Marioni liver data set using procedure 2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Rectangle 7"/>
          <p:cNvSpPr/>
          <p:nvPr/>
        </p:nvSpPr>
        <p:spPr>
          <a:xfrm>
            <a:off x="2268360" y="1268280"/>
            <a:ext cx="358920" cy="216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8" name="Picture 2" descr=""/>
          <p:cNvPicPr/>
          <p:nvPr/>
        </p:nvPicPr>
        <p:blipFill>
          <a:blip r:embed="rId1"/>
          <a:stretch/>
        </p:blipFill>
        <p:spPr>
          <a:xfrm>
            <a:off x="1413000" y="1593720"/>
            <a:ext cx="6318000" cy="3670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Rectangle 1"/>
          <p:cNvSpPr/>
          <p:nvPr/>
        </p:nvSpPr>
        <p:spPr>
          <a:xfrm>
            <a:off x="121680" y="817920"/>
            <a:ext cx="6165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SimSun"/>
              </a:rPr>
              <a:t>Additional file 11D. GAM plots for Marioni kidney data set using procedure 2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Rectangle 8"/>
          <p:cNvSpPr/>
          <p:nvPr/>
        </p:nvSpPr>
        <p:spPr>
          <a:xfrm>
            <a:off x="2268360" y="1268280"/>
            <a:ext cx="358920" cy="216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1" name="Picture 2" descr=""/>
          <p:cNvPicPr/>
          <p:nvPr/>
        </p:nvPicPr>
        <p:blipFill>
          <a:blip r:embed="rId1"/>
          <a:stretch/>
        </p:blipFill>
        <p:spPr>
          <a:xfrm>
            <a:off x="1413000" y="1593720"/>
            <a:ext cx="6318000" cy="3670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Rectangle 1"/>
          <p:cNvSpPr/>
          <p:nvPr/>
        </p:nvSpPr>
        <p:spPr>
          <a:xfrm>
            <a:off x="110520" y="817920"/>
            <a:ext cx="5661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SimSun"/>
              </a:rPr>
              <a:t>Additional file 11E. GAM plots for FRT-Seq data set using procedure 2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Rectangle 11"/>
          <p:cNvSpPr/>
          <p:nvPr/>
        </p:nvSpPr>
        <p:spPr>
          <a:xfrm>
            <a:off x="2268360" y="1268280"/>
            <a:ext cx="358920" cy="216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4" name="Picture 2" descr=""/>
          <p:cNvPicPr/>
          <p:nvPr/>
        </p:nvPicPr>
        <p:blipFill>
          <a:blip r:embed="rId1"/>
          <a:stretch/>
        </p:blipFill>
        <p:spPr>
          <a:xfrm>
            <a:off x="1413000" y="1593720"/>
            <a:ext cx="6318000" cy="3670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Rectangle 1"/>
          <p:cNvSpPr/>
          <p:nvPr/>
        </p:nvSpPr>
        <p:spPr>
          <a:xfrm>
            <a:off x="112680" y="817920"/>
            <a:ext cx="5848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SimSun"/>
              </a:rPr>
              <a:t>Additional file 11F. GAM plots for Lee35 yeast data set using procedure 1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Rectangle 11"/>
          <p:cNvSpPr/>
          <p:nvPr/>
        </p:nvSpPr>
        <p:spPr>
          <a:xfrm>
            <a:off x="2268360" y="1268280"/>
            <a:ext cx="358920" cy="216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7" name="Picture 2" descr=""/>
          <p:cNvPicPr/>
          <p:nvPr/>
        </p:nvPicPr>
        <p:blipFill>
          <a:blip r:embed="rId1"/>
          <a:stretch/>
        </p:blipFill>
        <p:spPr>
          <a:xfrm>
            <a:off x="1362240" y="1593720"/>
            <a:ext cx="6419520" cy="3670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Rectangle 1"/>
          <p:cNvSpPr/>
          <p:nvPr/>
        </p:nvSpPr>
        <p:spPr>
          <a:xfrm>
            <a:off x="119520" y="817920"/>
            <a:ext cx="7102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SimSun"/>
              </a:rPr>
              <a:t>Additional file 11G. GAM plots for Nagalakshmi oligo dT yeast data set using procedure 1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Rectangle 8"/>
          <p:cNvSpPr/>
          <p:nvPr/>
        </p:nvSpPr>
        <p:spPr>
          <a:xfrm>
            <a:off x="2268360" y="1268280"/>
            <a:ext cx="358920" cy="216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0" name="Picture 2" descr=""/>
          <p:cNvPicPr/>
          <p:nvPr/>
        </p:nvPicPr>
        <p:blipFill>
          <a:blip r:embed="rId1"/>
          <a:stretch/>
        </p:blipFill>
        <p:spPr>
          <a:xfrm>
            <a:off x="1413000" y="1593720"/>
            <a:ext cx="6318000" cy="3670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Rectangle 1"/>
          <p:cNvSpPr/>
          <p:nvPr/>
        </p:nvSpPr>
        <p:spPr>
          <a:xfrm>
            <a:off x="102240" y="817920"/>
            <a:ext cx="7783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SimSun"/>
              </a:rPr>
              <a:t>Additional file 11H. GAM plots for Nagalakshmi random hexamer yeast data set using procedure 1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Rectangle 8"/>
          <p:cNvSpPr/>
          <p:nvPr/>
        </p:nvSpPr>
        <p:spPr>
          <a:xfrm>
            <a:off x="2124000" y="1268280"/>
            <a:ext cx="360360" cy="216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3" name="Picture 2" descr=""/>
          <p:cNvPicPr/>
          <p:nvPr/>
        </p:nvPicPr>
        <p:blipFill>
          <a:blip r:embed="rId1"/>
          <a:stretch/>
        </p:blipFill>
        <p:spPr>
          <a:xfrm>
            <a:off x="1413000" y="1593720"/>
            <a:ext cx="6318000" cy="3670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06T17:32:57Z</dcterms:created>
  <dc:creator>Wei Zheng</dc:creator>
  <dc:description/>
  <dc:language>en-US</dc:language>
  <cp:lastModifiedBy>Wei Zheng</cp:lastModifiedBy>
  <dcterms:modified xsi:type="dcterms:W3CDTF">2011-06-06T17:33:09Z</dcterms:modified>
  <cp:revision>1</cp:revision>
  <dc:subject/>
  <dc:title>Slide 1</dc:title>
</cp:coreProperties>
</file>